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4" r:id="rId2"/>
  </p:sldIdLst>
  <p:sldSz cx="12192000" cy="162560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8" d="100"/>
          <a:sy n="48" d="100"/>
        </p:scale>
        <p:origin x="293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D4D038-C6CE-42E6-97AF-374B29BDA8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38" y="4621213"/>
            <a:ext cx="5851525" cy="37798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244350-582F-4423-88FA-07304E9481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3683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118D-F1B6-4265-B09D-A3420EA38694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D85-1B2C-430D-9549-1DAEE6716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3168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118D-F1B6-4265-B09D-A3420EA38694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D85-1B2C-430D-9549-1DAEE6716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146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118D-F1B6-4265-B09D-A3420EA38694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D85-1B2C-430D-9549-1DAEE6716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9076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118D-F1B6-4265-B09D-A3420EA38694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D85-1B2C-430D-9549-1DAEE6716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9416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118D-F1B6-4265-B09D-A3420EA38694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D85-1B2C-430D-9549-1DAEE6716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737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118D-F1B6-4265-B09D-A3420EA38694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D85-1B2C-430D-9549-1DAEE6716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464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118D-F1B6-4265-B09D-A3420EA38694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D85-1B2C-430D-9549-1DAEE6716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913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118D-F1B6-4265-B09D-A3420EA38694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D85-1B2C-430D-9549-1DAEE6716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261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118D-F1B6-4265-B09D-A3420EA38694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D85-1B2C-430D-9549-1DAEE6716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1528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118D-F1B6-4265-B09D-A3420EA38694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D85-1B2C-430D-9549-1DAEE6716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359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8118D-F1B6-4265-B09D-A3420EA38694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A3D85-1B2C-430D-9549-1DAEE6716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521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88118D-F1B6-4265-B09D-A3420EA38694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6A3D85-1B2C-430D-9549-1DAEE6716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709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3B63D25-B356-4E7F-9543-778B98CF44E7}"/>
              </a:ext>
            </a:extLst>
          </p:cNvPr>
          <p:cNvSpPr txBox="1"/>
          <p:nvPr/>
        </p:nvSpPr>
        <p:spPr>
          <a:xfrm>
            <a:off x="4291482" y="2479593"/>
            <a:ext cx="36822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Three-month-old mice, irradiated; p53 IHC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820C89C-D79B-41E3-86E1-99FBD5548285}"/>
              </a:ext>
            </a:extLst>
          </p:cNvPr>
          <p:cNvGrpSpPr/>
          <p:nvPr/>
        </p:nvGrpSpPr>
        <p:grpSpPr>
          <a:xfrm>
            <a:off x="2517771" y="2818533"/>
            <a:ext cx="7156457" cy="1994809"/>
            <a:chOff x="2312981" y="9517507"/>
            <a:chExt cx="7156457" cy="1994809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774262A-5137-4B54-A981-702864D57279}"/>
                </a:ext>
              </a:extLst>
            </p:cNvPr>
            <p:cNvSpPr txBox="1"/>
            <p:nvPr/>
          </p:nvSpPr>
          <p:spPr>
            <a:xfrm>
              <a:off x="2722400" y="9520937"/>
              <a:ext cx="13244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Wildtype; Trp53</a:t>
              </a:r>
              <a:r>
                <a:rPr lang="en-US" sz="1200" baseline="30000" dirty="0"/>
                <a:t>+/+</a:t>
              </a:r>
              <a:endParaRPr lang="en-US" sz="1200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6AFE74B-BB23-4D88-9164-B61D8E0494EF}"/>
                </a:ext>
              </a:extLst>
            </p:cNvPr>
            <p:cNvSpPr txBox="1"/>
            <p:nvPr/>
          </p:nvSpPr>
          <p:spPr>
            <a:xfrm>
              <a:off x="4889041" y="9517507"/>
              <a:ext cx="18324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Heterozygous; Trp53</a:t>
              </a:r>
              <a:r>
                <a:rPr lang="en-US" sz="1200" baseline="30000" dirty="0"/>
                <a:t>+/R270H</a:t>
              </a:r>
              <a:endParaRPr lang="en-US" sz="1200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D3DFF9E-F0B9-48B2-BEC5-D03C272E7A26}"/>
                </a:ext>
              </a:extLst>
            </p:cNvPr>
            <p:cNvSpPr txBox="1"/>
            <p:nvPr/>
          </p:nvSpPr>
          <p:spPr>
            <a:xfrm>
              <a:off x="7191540" y="9517507"/>
              <a:ext cx="20074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Homozygous; Trp53</a:t>
              </a:r>
              <a:r>
                <a:rPr lang="en-US" sz="1200" baseline="30000" dirty="0"/>
                <a:t>R270H/R270H</a:t>
              </a:r>
              <a:endParaRPr lang="en-US" sz="1200" dirty="0"/>
            </a:p>
          </p:txBody>
        </p:sp>
        <p:pic>
          <p:nvPicPr>
            <p:cNvPr id="7" name="Picture 6" descr="A picture containing text, fabric, porcelain&#10;&#10;Description automatically generated">
              <a:extLst>
                <a:ext uri="{FF2B5EF4-FFF2-40B4-BE49-F238E27FC236}">
                  <a16:creationId xmlns:a16="http://schemas.microsoft.com/office/drawing/2014/main" id="{DE9D6510-E318-4A0E-AB45-712844DB60C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137" t="7594" r="23330" b="13621"/>
            <a:stretch/>
          </p:blipFill>
          <p:spPr>
            <a:xfrm>
              <a:off x="2312981" y="9822639"/>
              <a:ext cx="2255885" cy="1689677"/>
            </a:xfrm>
            <a:prstGeom prst="rect">
              <a:avLst/>
            </a:prstGeom>
          </p:spPr>
        </p:pic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370A6080-D147-4C11-A2C1-C0804611235C}"/>
                </a:ext>
              </a:extLst>
            </p:cNvPr>
            <p:cNvGrpSpPr/>
            <p:nvPr/>
          </p:nvGrpSpPr>
          <p:grpSpPr>
            <a:xfrm>
              <a:off x="2333797" y="11404187"/>
              <a:ext cx="736493" cy="68924"/>
              <a:chOff x="1738078" y="5280860"/>
              <a:chExt cx="1911773" cy="191156"/>
            </a:xfrm>
          </p:grpSpPr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573D4C51-21F6-45D8-9FCD-F91703B86368}"/>
                  </a:ext>
                </a:extLst>
              </p:cNvPr>
              <p:cNvSpPr txBox="1"/>
              <p:nvPr/>
            </p:nvSpPr>
            <p:spPr>
              <a:xfrm>
                <a:off x="1738078" y="5280860"/>
                <a:ext cx="430064" cy="1911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00 um</a:t>
                </a:r>
              </a:p>
            </p:txBody>
          </p: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AC7051EB-3B4B-4DB5-B92C-F87089BEF3C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96430" y="5300602"/>
                <a:ext cx="185342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7CE21EB-872F-487B-B4AB-7B2616CFCA97}"/>
                </a:ext>
              </a:extLst>
            </p:cNvPr>
            <p:cNvSpPr txBox="1"/>
            <p:nvPr/>
          </p:nvSpPr>
          <p:spPr>
            <a:xfrm>
              <a:off x="4280835" y="11173762"/>
              <a:ext cx="2311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i</a:t>
              </a:r>
            </a:p>
          </p:txBody>
        </p:sp>
        <p:pic>
          <p:nvPicPr>
            <p:cNvPr id="10" name="Picture 9" descr="A picture containing fabric&#10;&#10;Description automatically generated">
              <a:extLst>
                <a:ext uri="{FF2B5EF4-FFF2-40B4-BE49-F238E27FC236}">
                  <a16:creationId xmlns:a16="http://schemas.microsoft.com/office/drawing/2014/main" id="{736EC070-4FCF-4C88-8494-AC4BFF16D9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16" t="8760" r="25719" b="19030"/>
            <a:stretch/>
          </p:blipFill>
          <p:spPr>
            <a:xfrm>
              <a:off x="4725442" y="9841559"/>
              <a:ext cx="2244039" cy="1631552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FE8BD1D-7744-4879-BBB5-C543E26C7EF9}"/>
                </a:ext>
              </a:extLst>
            </p:cNvPr>
            <p:cNvSpPr txBox="1"/>
            <p:nvPr/>
          </p:nvSpPr>
          <p:spPr>
            <a:xfrm>
              <a:off x="6675260" y="11131963"/>
              <a:ext cx="27764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ii</a:t>
              </a:r>
            </a:p>
          </p:txBody>
        </p:sp>
        <p:pic>
          <p:nvPicPr>
            <p:cNvPr id="12" name="Picture 11" descr="A picture containing text, fabric&#10;&#10;Description automatically generated">
              <a:extLst>
                <a:ext uri="{FF2B5EF4-FFF2-40B4-BE49-F238E27FC236}">
                  <a16:creationId xmlns:a16="http://schemas.microsoft.com/office/drawing/2014/main" id="{2C556F50-1389-4948-9850-B8248B25B6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90" t="12794" r="17626" b="12443"/>
            <a:stretch/>
          </p:blipFill>
          <p:spPr>
            <a:xfrm>
              <a:off x="7119725" y="9842303"/>
              <a:ext cx="2349713" cy="1628214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94CB555-9E4C-4554-A82D-CC063DB126C3}"/>
                </a:ext>
              </a:extLst>
            </p:cNvPr>
            <p:cNvSpPr txBox="1"/>
            <p:nvPr/>
          </p:nvSpPr>
          <p:spPr>
            <a:xfrm>
              <a:off x="9111987" y="11105234"/>
              <a:ext cx="32412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iii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3575C55-CD0F-4391-A932-40A9E4E62FCB}"/>
                </a:ext>
              </a:extLst>
            </p:cNvPr>
            <p:cNvSpPr txBox="1"/>
            <p:nvPr/>
          </p:nvSpPr>
          <p:spPr>
            <a:xfrm>
              <a:off x="2342566" y="9864642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p53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09E9F1E-D79F-4C10-AC2E-E229E7D7580C}"/>
                </a:ext>
              </a:extLst>
            </p:cNvPr>
            <p:cNvSpPr txBox="1"/>
            <p:nvPr/>
          </p:nvSpPr>
          <p:spPr>
            <a:xfrm>
              <a:off x="4719110" y="9841945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p53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D5E0C13-ED34-4E9B-BC5F-02CB46CD832D}"/>
                </a:ext>
              </a:extLst>
            </p:cNvPr>
            <p:cNvSpPr txBox="1"/>
            <p:nvPr/>
          </p:nvSpPr>
          <p:spPr>
            <a:xfrm>
              <a:off x="7073135" y="984155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p5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80987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45</TotalTime>
  <Words>29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th Vinall</dc:creator>
  <cp:lastModifiedBy>Ruth Vinall</cp:lastModifiedBy>
  <cp:revision>117</cp:revision>
  <cp:lastPrinted>2019-03-05T18:39:14Z</cp:lastPrinted>
  <dcterms:created xsi:type="dcterms:W3CDTF">2018-06-04T18:37:57Z</dcterms:created>
  <dcterms:modified xsi:type="dcterms:W3CDTF">2021-12-10T18:13:10Z</dcterms:modified>
</cp:coreProperties>
</file>